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14400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7FB7F11-820F-49D4-8385-A1CF4FF9B689}" v="1" dt="2021-10-08T10:48:34.8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g Ho" userId="3459b55388f68bf5" providerId="LiveId" clId="{37FB7F11-820F-49D4-8385-A1CF4FF9B689}"/>
    <pc:docChg chg="modSld">
      <pc:chgData name="Kang Ho" userId="3459b55388f68bf5" providerId="LiveId" clId="{37FB7F11-820F-49D4-8385-A1CF4FF9B689}" dt="2021-10-08T10:48:43.697" v="50" actId="1036"/>
      <pc:docMkLst>
        <pc:docMk/>
      </pc:docMkLst>
      <pc:sldChg chg="addSp modSp mod">
        <pc:chgData name="Kang Ho" userId="3459b55388f68bf5" providerId="LiveId" clId="{37FB7F11-820F-49D4-8385-A1CF4FF9B689}" dt="2021-10-08T10:48:43.697" v="50" actId="1036"/>
        <pc:sldMkLst>
          <pc:docMk/>
          <pc:sldMk cId="2539464751" sldId="259"/>
        </pc:sldMkLst>
        <pc:spChg chg="mod">
          <ac:chgData name="Kang Ho" userId="3459b55388f68bf5" providerId="LiveId" clId="{37FB7F11-820F-49D4-8385-A1CF4FF9B689}" dt="2021-10-08T10:48:43.697" v="50" actId="1036"/>
          <ac:spMkLst>
            <pc:docMk/>
            <pc:sldMk cId="2539464751" sldId="259"/>
            <ac:spMk id="2" creationId="{8B5B0C05-C8DE-1248-B77C-25C86BB90B7F}"/>
          </ac:spMkLst>
        </pc:spChg>
        <pc:spChg chg="mod">
          <ac:chgData name="Kang Ho" userId="3459b55388f68bf5" providerId="LiveId" clId="{37FB7F11-820F-49D4-8385-A1CF4FF9B689}" dt="2021-10-08T10:48:43.697" v="50" actId="1036"/>
          <ac:spMkLst>
            <pc:docMk/>
            <pc:sldMk cId="2539464751" sldId="259"/>
            <ac:spMk id="7" creationId="{A06F1898-BBB4-AD47-96CD-81765755583C}"/>
          </ac:spMkLst>
        </pc:spChg>
        <pc:spChg chg="mod">
          <ac:chgData name="Kang Ho" userId="3459b55388f68bf5" providerId="LiveId" clId="{37FB7F11-820F-49D4-8385-A1CF4FF9B689}" dt="2021-10-08T10:48:43.697" v="50" actId="1036"/>
          <ac:spMkLst>
            <pc:docMk/>
            <pc:sldMk cId="2539464751" sldId="259"/>
            <ac:spMk id="8" creationId="{B90B355B-918E-6242-A756-76BAACCE76DC}"/>
          </ac:spMkLst>
        </pc:spChg>
        <pc:spChg chg="add mod">
          <ac:chgData name="Kang Ho" userId="3459b55388f68bf5" providerId="LiveId" clId="{37FB7F11-820F-49D4-8385-A1CF4FF9B689}" dt="2021-10-08T10:48:34.822" v="0"/>
          <ac:spMkLst>
            <pc:docMk/>
            <pc:sldMk cId="2539464751" sldId="259"/>
            <ac:spMk id="9" creationId="{CF253A3C-8019-4848-8BF5-A4DCF24E8AF0}"/>
          </ac:spMkLst>
        </pc:spChg>
        <pc:picChg chg="mod">
          <ac:chgData name="Kang Ho" userId="3459b55388f68bf5" providerId="LiveId" clId="{37FB7F11-820F-49D4-8385-A1CF4FF9B689}" dt="2021-10-08T10:48:43.697" v="50" actId="1036"/>
          <ac:picMkLst>
            <pc:docMk/>
            <pc:sldMk cId="2539464751" sldId="259"/>
            <ac:picMk id="5" creationId="{00000000-0000-0000-0000-000000000000}"/>
          </ac:picMkLst>
        </pc:picChg>
      </pc:sldChg>
    </pc:docChg>
  </pc:docChgLst>
  <pc:docChgLst>
    <pc:chgData name="Kang Ho" userId="3459b55388f68bf5" providerId="LiveId" clId="{2DCF6B39-8FF1-4E23-9FD0-106D048EE18F}"/>
    <pc:docChg chg="addSld delSld modSld">
      <pc:chgData name="Kang Ho" userId="3459b55388f68bf5" providerId="LiveId" clId="{2DCF6B39-8FF1-4E23-9FD0-106D048EE18F}" dt="2021-03-10T04:03:50.596" v="1" actId="47"/>
      <pc:docMkLst>
        <pc:docMk/>
      </pc:docMkLst>
      <pc:sldChg chg="add">
        <pc:chgData name="Kang Ho" userId="3459b55388f68bf5" providerId="LiveId" clId="{2DCF6B39-8FF1-4E23-9FD0-106D048EE18F}" dt="2021-03-10T04:03:49.457" v="0"/>
        <pc:sldMkLst>
          <pc:docMk/>
          <pc:sldMk cId="2539464751" sldId="259"/>
        </pc:sldMkLst>
      </pc:sldChg>
      <pc:sldChg chg="del">
        <pc:chgData name="Kang Ho" userId="3459b55388f68bf5" providerId="LiveId" clId="{2DCF6B39-8FF1-4E23-9FD0-106D048EE18F}" dt="2021-03-10T04:03:50.596" v="1" actId="47"/>
        <pc:sldMkLst>
          <pc:docMk/>
          <pc:sldMk cId="350311653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620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5685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181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067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433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740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997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1318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0540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284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519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1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1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5722" y="3605288"/>
            <a:ext cx="11150550" cy="43468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131975" y="13467114"/>
            <a:ext cx="1395226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2400" baseline="0" dirty="0">
                <a:latin typeface="Arial" panose="020B0604020202020204" pitchFamily="34" charset="0"/>
                <a:cs typeface="Arial" panose="020B0604020202020204" pitchFamily="34" charset="0"/>
              </a:rPr>
              <a:t> Figure 3.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Validation of the proteomic results. Western blot analysis of EPCAM (a) and  P4BH(b). One asterisk (*) indicates p-value &lt; 0.05. </a:t>
            </a:r>
            <a:endParaRPr lang="en-US" sz="240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B5B0C05-C8DE-1248-B77C-25C86BB90B7F}"/>
              </a:ext>
            </a:extLst>
          </p:cNvPr>
          <p:cNvSpPr txBox="1"/>
          <p:nvPr/>
        </p:nvSpPr>
        <p:spPr>
          <a:xfrm>
            <a:off x="1445722" y="3559568"/>
            <a:ext cx="500063" cy="5909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ko-Kore-DE" dirty="0"/>
              <a:t>a</a:t>
            </a:r>
            <a:endParaRPr kumimoji="1" lang="ko-Kore-DE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06F1898-BBB4-AD47-96CD-81765755583C}"/>
              </a:ext>
            </a:extLst>
          </p:cNvPr>
          <p:cNvSpPr txBox="1"/>
          <p:nvPr/>
        </p:nvSpPr>
        <p:spPr>
          <a:xfrm>
            <a:off x="7020997" y="3559568"/>
            <a:ext cx="500063" cy="5909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ko-Kore-DE" dirty="0"/>
              <a:t>B</a:t>
            </a:r>
            <a:endParaRPr kumimoji="1" lang="ko-Kore-DE" alt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0B355B-918E-6242-A756-76BAACCE76DC}"/>
              </a:ext>
            </a:extLst>
          </p:cNvPr>
          <p:cNvSpPr txBox="1"/>
          <p:nvPr/>
        </p:nvSpPr>
        <p:spPr>
          <a:xfrm>
            <a:off x="7053640" y="3559568"/>
            <a:ext cx="500063" cy="5909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ko-Kore-DE" dirty="0"/>
              <a:t>b</a:t>
            </a:r>
            <a:endParaRPr kumimoji="1" lang="ko-Kore-DE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253A3C-8019-4848-8BF5-A4DCF24E8AF0}"/>
              </a:ext>
            </a:extLst>
          </p:cNvPr>
          <p:cNvSpPr txBox="1"/>
          <p:nvPr/>
        </p:nvSpPr>
        <p:spPr>
          <a:xfrm>
            <a:off x="324752" y="453803"/>
            <a:ext cx="137417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itl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n-depth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fili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ap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btype-specif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raniopharyngioma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Jung Hee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y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is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eong-Ik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Park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ohyu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Yo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wy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</a:p>
          <a:p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464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69</Words>
  <Application>Microsoft Office PowerPoint</Application>
  <PresentationFormat>사용자 지정</PresentationFormat>
  <Paragraphs>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ng Ho</dc:creator>
  <cp:lastModifiedBy>Kang Ho</cp:lastModifiedBy>
  <cp:revision>2</cp:revision>
  <dcterms:created xsi:type="dcterms:W3CDTF">2021-03-10T03:54:49Z</dcterms:created>
  <dcterms:modified xsi:type="dcterms:W3CDTF">2021-10-08T10:48:45Z</dcterms:modified>
</cp:coreProperties>
</file>